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361" autoAdjust="0"/>
    <p:restoredTop sz="94660"/>
  </p:normalViewPr>
  <p:slideViewPr>
    <p:cSldViewPr snapToGrid="0">
      <p:cViewPr varScale="1">
        <p:scale>
          <a:sx n="75" d="100"/>
          <a:sy n="75" d="100"/>
        </p:scale>
        <p:origin x="66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948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097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255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4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79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85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83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43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145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46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726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A002-9231-4873-B80D-7DA697758235}" type="datetimeFigureOut">
              <a:rPr kumimoji="1" lang="ja-JP" altLang="en-US" smtClean="0"/>
              <a:t>2017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6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54" r="2362" b="1258"/>
          <a:stretch/>
        </p:blipFill>
        <p:spPr>
          <a:xfrm>
            <a:off x="117132" y="3558379"/>
            <a:ext cx="6696000" cy="306000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5900ADF-8EF5-4D83-A439-840A0746185E}"/>
              </a:ext>
            </a:extLst>
          </p:cNvPr>
          <p:cNvSpPr txBox="1"/>
          <p:nvPr/>
        </p:nvSpPr>
        <p:spPr>
          <a:xfrm>
            <a:off x="3420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2402C89-0330-4298-AE84-F5E94ADD94C0}"/>
              </a:ext>
            </a:extLst>
          </p:cNvPr>
          <p:cNvSpPr txBox="1"/>
          <p:nvPr/>
        </p:nvSpPr>
        <p:spPr>
          <a:xfrm rot="-5400000">
            <a:off x="2332800" y="1462919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529C713-4E64-428E-8F64-9A310996A0CC}"/>
              </a:ext>
            </a:extLst>
          </p:cNvPr>
          <p:cNvSpPr txBox="1"/>
          <p:nvPr/>
        </p:nvSpPr>
        <p:spPr>
          <a:xfrm>
            <a:off x="44856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633FE538-4C28-4F87-80C8-1307C2B01A6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000" y="180000"/>
            <a:ext cx="2952750" cy="2952750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74490B8-E930-4CBC-B215-4368D19E4EAF}"/>
              </a:ext>
            </a:extLst>
          </p:cNvPr>
          <p:cNvSpPr txBox="1"/>
          <p:nvPr/>
        </p:nvSpPr>
        <p:spPr>
          <a:xfrm>
            <a:off x="36000" y="6426769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EF6AD04-00A0-4B3C-9FD2-3C217B78FF70}"/>
              </a:ext>
            </a:extLst>
          </p:cNvPr>
          <p:cNvSpPr txBox="1"/>
          <p:nvPr/>
        </p:nvSpPr>
        <p:spPr>
          <a:xfrm rot="-5400000">
            <a:off x="-1080000" y="7853687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AB180D3-5D79-42B0-9AB8-74533AD01367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896D1C12-99F4-4ADD-B588-EE65F1EAE9F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570769"/>
            <a:ext cx="2952750" cy="2952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9608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58</TotalTime>
  <Words>54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幸二</dc:creator>
  <cp:lastModifiedBy>門田幸二</cp:lastModifiedBy>
  <cp:revision>100</cp:revision>
  <dcterms:created xsi:type="dcterms:W3CDTF">2015-02-09T07:01:03Z</dcterms:created>
  <dcterms:modified xsi:type="dcterms:W3CDTF">2017-08-24T10:50:35Z</dcterms:modified>
</cp:coreProperties>
</file>